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23" autoAdjust="0"/>
    <p:restoredTop sz="88632" autoAdjust="0"/>
  </p:normalViewPr>
  <p:slideViewPr>
    <p:cSldViewPr snapToGrid="0" snapToObjects="1">
      <p:cViewPr>
        <p:scale>
          <a:sx n="70" d="100"/>
          <a:sy n="70" d="100"/>
        </p:scale>
        <p:origin x="-2292" y="3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1B3F9F-F21E-493F-BFEA-F1D2D09CFAD3}" type="datetimeFigureOut">
              <a:rPr lang="en-CA" smtClean="0"/>
              <a:pPr/>
              <a:t>22/05/201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345854-6294-413A-9C21-02DA63F77C4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1507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345854-6294-413A-9C21-02DA63F77C4A}" type="slidenum">
              <a:rPr lang="en-CA" smtClean="0"/>
              <a:pPr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584316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949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657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89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26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921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430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6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742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614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702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793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67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98635" y="4790396"/>
            <a:ext cx="5083608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Fig.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ice inoculated with CFA/PBS/PT do not exhibit clinical or immunological symptoms of EAE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linical scoring of EAE severity after inoculation of WT mice with 50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  <a:r>
              <a:rPr lang="en-CA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CFA (WT) or PBS in CFA (WT mock) (day 0) and 300 ng pertussis toxin (day 0 and 2) for 40 days (N=9). Numbers of macrophages (MØ, CD11b+/CD45 high), microglia (MG, CD11b+/CD45 low), CD4+ T cells (CD4+/CD3+), CD8+ T cells (CD8+/CD3+) and B cells (B220+/CD45+) isolated from the spinal cord (via a discontinuous percoll gradient) of mice 15 days following inoculation with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  <a:r>
              <a:rPr lang="en-CA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n= 3)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ta presented as mean+/- SEM; significant differences (Clinical data, Kruskal-Wallis;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unpaired students t-test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&lt;0.05) from the WT internal control are denoted by asterisks (*).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54" name="Picture 30" descr="C:\Users\Euan\Desktop\Euan's LAB NEW\Manuscripts\CAT EAE Manuscript\CAT BSL Paper\Prizm FIles\High Res pannels\S2 a Clinical EAE mock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855657" y="723128"/>
            <a:ext cx="5687568" cy="19110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5" name="Picture 31" descr="C:\Users\Euan\Desktop\Euan's LAB NEW\Manuscripts\CAT EAE Manuscript\CAT BSL Paper\Prizm FIles\High Res pannels\S2 b WT vs mock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479" y="2717173"/>
            <a:ext cx="2414016" cy="1694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512129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93</TotalTime>
  <Words>169</Words>
  <Application>Microsoft Office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Euan</cp:lastModifiedBy>
  <cp:revision>1550</cp:revision>
  <dcterms:created xsi:type="dcterms:W3CDTF">2012-09-11T17:14:12Z</dcterms:created>
  <dcterms:modified xsi:type="dcterms:W3CDTF">2015-05-22T19:07:21Z</dcterms:modified>
</cp:coreProperties>
</file>